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7" r:id="rId2"/>
    <p:sldId id="279" r:id="rId3"/>
    <p:sldId id="280" r:id="rId4"/>
    <p:sldId id="278" r:id="rId5"/>
    <p:sldId id="275" r:id="rId6"/>
    <p:sldId id="276" r:id="rId7"/>
    <p:sldId id="269" r:id="rId8"/>
    <p:sldId id="271" r:id="rId9"/>
    <p:sldId id="270" r:id="rId10"/>
    <p:sldId id="273" r:id="rId11"/>
    <p:sldId id="272" r:id="rId12"/>
    <p:sldId id="274" r:id="rId1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770BAFB-0EE2-CC42-918C-B70AABE86206}" v="1" dt="2024-01-25T04:04:11.647"/>
    <p1510:client id="{F0A59378-415D-4B79-AD5D-72858DDB184E}" v="21" dt="2024-01-25T21:30:49.13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43"/>
    <p:restoredTop sz="96327"/>
  </p:normalViewPr>
  <p:slideViewPr>
    <p:cSldViewPr snapToGrid="0">
      <p:cViewPr varScale="1">
        <p:scale>
          <a:sx n="131" d="100"/>
          <a:sy n="131" d="100"/>
        </p:scale>
        <p:origin x="368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C6CDD1-BCAD-3485-A4A2-5D41753E6CA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3B9ADF6-5B27-B066-0DBF-3168037F599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9B0E39-B8AB-A896-5DC1-72FC6D9D13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48B14-6B17-744D-888B-DBFD19B3DA53}" type="datetimeFigureOut">
              <a:rPr lang="en-US" smtClean="0"/>
              <a:t>1/3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C8EFB9-193F-C370-E982-016FB0590D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3C1F09-DFA8-8ED5-67D7-70D86350C7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45DBA-97CA-A84D-AC99-1BECF8A74B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4741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C78C5B-6F98-8F85-FE38-E988BFEC73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77C4192-2AC3-53FF-D032-7538E247294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2301DE-3AC0-E0D3-3DDB-654190ED6C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48B14-6B17-744D-888B-DBFD19B3DA53}" type="datetimeFigureOut">
              <a:rPr lang="en-US" smtClean="0"/>
              <a:t>1/3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2E810A-120D-ED1D-8F45-82512B325D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CA4854-8DFC-C271-7FE2-95BAC9FD67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45DBA-97CA-A84D-AC99-1BECF8A74B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34161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2C8CAAD-C247-5276-EC8F-B69F695D4DD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3415328-D7FF-F85B-DF7D-2F8E573CE56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83A5A6C-A12D-309A-72C0-B319B28BB8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48B14-6B17-744D-888B-DBFD19B3DA53}" type="datetimeFigureOut">
              <a:rPr lang="en-US" smtClean="0"/>
              <a:t>1/3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3B445D-5EF2-8EFF-A4E4-32A1C6F313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28C30C-0EEE-8860-4BB3-240A6CDCA3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45DBA-97CA-A84D-AC99-1BECF8A74B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92097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477E6C-3ADA-BFE8-FF72-861FE6B342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2DAC577-CB86-94D1-24DA-548A273E6FB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596851-F828-6575-9A9B-17B5500A1C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48B14-6B17-744D-888B-DBFD19B3DA53}" type="datetimeFigureOut">
              <a:rPr lang="en-US" smtClean="0"/>
              <a:t>1/3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38C437-9535-7D2C-3CB5-E272A23CA2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9F28F3-B636-B8B8-8B1E-CABD283C63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45DBA-97CA-A84D-AC99-1BECF8A74B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54469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8BD5CB-276D-F79D-5BBE-DABC5BF0C6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13C55C5-0402-3D1F-E366-23ABAB07D1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8EC303-F2CF-D6F3-42D1-F4E24B2D9F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48B14-6B17-744D-888B-DBFD19B3DA53}" type="datetimeFigureOut">
              <a:rPr lang="en-US" smtClean="0"/>
              <a:t>1/3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D90CF7-D211-1B36-CAC0-2DE42CA90A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D11AD13-A1BB-F19B-D9D6-715BC15255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45DBA-97CA-A84D-AC99-1BECF8A74B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54853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05E092-11EC-1607-FAB3-9820C6C5DF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B789127-5D29-169F-89A3-585EFDA76A0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F25A323-2323-84FE-0692-83355EBA2FF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6852530-6B2D-C811-A699-6B0873A759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48B14-6B17-744D-888B-DBFD19B3DA53}" type="datetimeFigureOut">
              <a:rPr lang="en-US" smtClean="0"/>
              <a:t>1/3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7C1423E-6915-5A36-781F-243CFBACFD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5CF01A3-C262-BACB-20EF-FEDE626B36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45DBA-97CA-A84D-AC99-1BECF8A74B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41698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B26CCE-6816-A84F-546B-BDD941D42C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A5D4569-6DBB-B4BB-F32E-3A07A712BB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DFD8671-C815-2B31-BA5F-C6CD8758446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510FEC5-FF1C-4AE2-66F3-504673932A5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3AB3BD9-9E22-F213-C90B-A0465701240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55D213C-13AF-2172-D742-6A545D4C3B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48B14-6B17-744D-888B-DBFD19B3DA53}" type="datetimeFigureOut">
              <a:rPr lang="en-US" smtClean="0"/>
              <a:t>1/30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8849E39-0E06-BF2C-F117-4943F46D55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9B91F0E-3C12-F78A-402F-D655A00F40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45DBA-97CA-A84D-AC99-1BECF8A74B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48802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59F6FF-A12D-DC00-E343-FB60EC55C9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E84A733-CF5B-2C60-91B3-797D2D07B6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48B14-6B17-744D-888B-DBFD19B3DA53}" type="datetimeFigureOut">
              <a:rPr lang="en-US" smtClean="0"/>
              <a:t>1/30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2F7F8DE-FD4E-37A9-B6DF-182C5F679E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BB99B1E-07A7-B3BA-F204-337CECAD28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45DBA-97CA-A84D-AC99-1BECF8A74B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93412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FDA5546-338E-9899-5A98-4266A7BDF0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48B14-6B17-744D-888B-DBFD19B3DA53}" type="datetimeFigureOut">
              <a:rPr lang="en-US" smtClean="0"/>
              <a:t>1/30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5CAD1C7-6508-1E04-1A15-864151BD9E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D6B1F4C-6A34-216E-9405-33FD2E537B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45DBA-97CA-A84D-AC99-1BECF8A74B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42449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E90217-A3F6-A5EB-C458-341937780B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42A63CC-DA88-7D22-CA15-B45023237EC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279121F-6243-762C-ADDC-2E2412FF0A8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F864883-E6F1-7F41-11EF-81FB804457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48B14-6B17-744D-888B-DBFD19B3DA53}" type="datetimeFigureOut">
              <a:rPr lang="en-US" smtClean="0"/>
              <a:t>1/3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6F97308-E472-4C56-C188-4B9220ACE7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CD0A1A3-1FC3-EF4F-3209-9E7E159C51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45DBA-97CA-A84D-AC99-1BECF8A74B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11715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6E8259-0733-BDEC-72AF-2CFE1D3BE3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6D8D162-356D-A21C-A204-D9350E07720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670EDF8-5979-5466-8EAC-FEA784F967B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AEE4983-8778-5404-3189-22F315E8D9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48B14-6B17-744D-888B-DBFD19B3DA53}" type="datetimeFigureOut">
              <a:rPr lang="en-US" smtClean="0"/>
              <a:t>1/3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11239E2-1554-2BCB-3940-2A4D1614C4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5869B06-DBC6-F879-7EDB-8FCEBD005C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45DBA-97CA-A84D-AC99-1BECF8A74B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34437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192B5FA-4D18-8AC4-8292-835CE36E88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EDB8872-8E32-EC14-FCC5-48F74641DB6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522226-CF4A-862D-D49B-C7BA7DFD03C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E48B14-6B17-744D-888B-DBFD19B3DA53}" type="datetimeFigureOut">
              <a:rPr lang="en-US" smtClean="0"/>
              <a:t>1/3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911CE8-04CE-F2E0-73AF-7F38F29CE09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38C643-6B96-E37B-5BB4-94334265269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245DBA-97CA-A84D-AC99-1BECF8A74B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67392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10.xml.rels><?xml version="1.0" encoding="UTF-8" standalone="yes"?>
<Relationships xmlns="http://schemas.openxmlformats.org/package/2006/relationships"><Relationship Id="rId3" Type="http://schemas.microsoft.com/office/2007/relationships/hdphoto" Target="../media/hdphoto9.wdp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5" Type="http://schemas.microsoft.com/office/2007/relationships/hdphoto" Target="../media/hdphoto10.wdp"/><Relationship Id="rId4" Type="http://schemas.openxmlformats.org/officeDocument/2006/relationships/image" Target="../media/image14.png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microsoft.com/office/2007/relationships/hdphoto" Target="../media/hdphoto11.wdp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4" Type="http://schemas.microsoft.com/office/2007/relationships/hdphoto" Target="../media/hdphoto3.wdp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4.wdp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5.wdp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microsoft.com/office/2007/relationships/hdphoto" Target="../media/hdphoto6.wdp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microsoft.com/office/2007/relationships/hdphoto" Target="../media/hdphoto7.wdp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microsoft.com/office/2007/relationships/hdphoto" Target="../media/hdphoto8.wdp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17E071D-1EF8-796C-1049-DC86DB47F6E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63B517AE-D74E-C1D5-47DC-18EBB5F14CD7}"/>
              </a:ext>
            </a:extLst>
          </p:cNvPr>
          <p:cNvSpPr txBox="1"/>
          <p:nvPr/>
        </p:nvSpPr>
        <p:spPr>
          <a:xfrm>
            <a:off x="4510267" y="457201"/>
            <a:ext cx="252713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 hTCEpi EV CD9 WB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3A32AED-3FC3-F276-6972-0ED2613E3EB7}"/>
              </a:ext>
            </a:extLst>
          </p:cNvPr>
          <p:cNvSpPr txBox="1"/>
          <p:nvPr/>
        </p:nvSpPr>
        <p:spPr>
          <a:xfrm>
            <a:off x="2648961" y="3244334"/>
            <a:ext cx="6977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D9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248851F-7AE6-AE1C-F5CE-D6BCF7F42D2E}"/>
              </a:ext>
            </a:extLst>
          </p:cNvPr>
          <p:cNvSpPr txBox="1"/>
          <p:nvPr/>
        </p:nvSpPr>
        <p:spPr>
          <a:xfrm>
            <a:off x="3968862" y="1913471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2E61905-446B-E761-B04F-D6EB4F53AB19}"/>
              </a:ext>
            </a:extLst>
          </p:cNvPr>
          <p:cNvSpPr txBox="1"/>
          <p:nvPr/>
        </p:nvSpPr>
        <p:spPr>
          <a:xfrm>
            <a:off x="4305322" y="1906791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2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9AAD829-E21D-98BB-CAA3-F16D9C00CF79}"/>
              </a:ext>
            </a:extLst>
          </p:cNvPr>
          <p:cNvSpPr txBox="1"/>
          <p:nvPr/>
        </p:nvSpPr>
        <p:spPr>
          <a:xfrm>
            <a:off x="6782981" y="1894833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374B0A2-2622-8F34-4475-E48E81185086}"/>
              </a:ext>
            </a:extLst>
          </p:cNvPr>
          <p:cNvSpPr txBox="1"/>
          <p:nvPr/>
        </p:nvSpPr>
        <p:spPr>
          <a:xfrm>
            <a:off x="7067017" y="1901046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C8E88C9-2444-7388-45DD-667C4D5FE5FA}"/>
              </a:ext>
            </a:extLst>
          </p:cNvPr>
          <p:cNvSpPr txBox="1"/>
          <p:nvPr/>
        </p:nvSpPr>
        <p:spPr>
          <a:xfrm>
            <a:off x="5423208" y="1913471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WCL</a:t>
            </a: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4CBE0E0E-578F-CC6D-F549-3CB4831D8C20}"/>
              </a:ext>
            </a:extLst>
          </p:cNvPr>
          <p:cNvCxnSpPr/>
          <p:nvPr/>
        </p:nvCxnSpPr>
        <p:spPr>
          <a:xfrm>
            <a:off x="4091940" y="1909820"/>
            <a:ext cx="83665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5C35BD5E-3E3D-E6AE-9C8F-79C91EDD662F}"/>
              </a:ext>
            </a:extLst>
          </p:cNvPr>
          <p:cNvSpPr txBox="1"/>
          <p:nvPr/>
        </p:nvSpPr>
        <p:spPr>
          <a:xfrm>
            <a:off x="4039391" y="1553717"/>
            <a:ext cx="10226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ontrol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DDF70C45-0FDE-3FBC-595F-76AACA2558C6}"/>
              </a:ext>
            </a:extLst>
          </p:cNvPr>
          <p:cNvCxnSpPr/>
          <p:nvPr/>
        </p:nvCxnSpPr>
        <p:spPr>
          <a:xfrm>
            <a:off x="6799712" y="1866839"/>
            <a:ext cx="83665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0A9AED8A-5B16-6ADE-5423-267BA23D3EB6}"/>
              </a:ext>
            </a:extLst>
          </p:cNvPr>
          <p:cNvSpPr txBox="1"/>
          <p:nvPr/>
        </p:nvSpPr>
        <p:spPr>
          <a:xfrm>
            <a:off x="6799712" y="1497507"/>
            <a:ext cx="8366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PA0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4E0612F-FD2F-F010-22B8-95EF295C2D92}"/>
              </a:ext>
            </a:extLst>
          </p:cNvPr>
          <p:cNvSpPr txBox="1"/>
          <p:nvPr/>
        </p:nvSpPr>
        <p:spPr>
          <a:xfrm>
            <a:off x="8844563" y="3346541"/>
            <a:ext cx="789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8kDa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55BF6F13-012C-488E-3D79-781D948B9C5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-20000"/>
                    </a14:imgEffect>
                  </a14:imgLayer>
                </a14:imgProps>
              </a:ext>
            </a:extLst>
          </a:blip>
          <a:srcRect l="7085" b="59478"/>
          <a:stretch/>
        </p:blipFill>
        <p:spPr>
          <a:xfrm>
            <a:off x="3156829" y="2257952"/>
            <a:ext cx="2835789" cy="165189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39332939-8DFF-599B-D066-7F8C0AEECE7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58544"/>
          <a:stretch/>
        </p:blipFill>
        <p:spPr>
          <a:xfrm>
            <a:off x="6058652" y="2257952"/>
            <a:ext cx="2785911" cy="16518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4617371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5A06081-E539-DBEF-1CB9-3D19478A8E2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8638DA29-492D-56D0-78D7-CDDE1B10B629}"/>
              </a:ext>
            </a:extLst>
          </p:cNvPr>
          <p:cNvSpPr txBox="1"/>
          <p:nvPr/>
        </p:nvSpPr>
        <p:spPr>
          <a:xfrm>
            <a:off x="4510267" y="457201"/>
            <a:ext cx="252713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HBEC EV Flotillin WB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81C5A04-9447-5C8D-9905-956F16CBF7B3}"/>
              </a:ext>
            </a:extLst>
          </p:cNvPr>
          <p:cNvSpPr txBox="1"/>
          <p:nvPr/>
        </p:nvSpPr>
        <p:spPr>
          <a:xfrm>
            <a:off x="2223992" y="3059668"/>
            <a:ext cx="9935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lotillin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8F8E9AC-F9F1-093C-C48B-6565EC61371C}"/>
              </a:ext>
            </a:extLst>
          </p:cNvPr>
          <p:cNvSpPr txBox="1"/>
          <p:nvPr/>
        </p:nvSpPr>
        <p:spPr>
          <a:xfrm>
            <a:off x="9178232" y="2906377"/>
            <a:ext cx="789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48kD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62F566E-F437-D5DF-24C2-767A3598221D}"/>
              </a:ext>
            </a:extLst>
          </p:cNvPr>
          <p:cNvSpPr txBox="1"/>
          <p:nvPr/>
        </p:nvSpPr>
        <p:spPr>
          <a:xfrm>
            <a:off x="4109799" y="1873589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FFFEF92-6F04-4202-2C9F-0448A026A6A0}"/>
              </a:ext>
            </a:extLst>
          </p:cNvPr>
          <p:cNvSpPr txBox="1"/>
          <p:nvPr/>
        </p:nvSpPr>
        <p:spPr>
          <a:xfrm>
            <a:off x="4496970" y="1870695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2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BDE0701-00E6-56C3-B178-F5BCC2AF2756}"/>
              </a:ext>
            </a:extLst>
          </p:cNvPr>
          <p:cNvSpPr txBox="1"/>
          <p:nvPr/>
        </p:nvSpPr>
        <p:spPr>
          <a:xfrm>
            <a:off x="7084221" y="1853786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D81429A-C26F-AB7A-7F13-781D09FE24F8}"/>
              </a:ext>
            </a:extLst>
          </p:cNvPr>
          <p:cNvSpPr txBox="1"/>
          <p:nvPr/>
        </p:nvSpPr>
        <p:spPr>
          <a:xfrm>
            <a:off x="7427166" y="1855778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A757C93-3392-1F0D-CE86-213BADE07EF6}"/>
              </a:ext>
            </a:extLst>
          </p:cNvPr>
          <p:cNvSpPr txBox="1"/>
          <p:nvPr/>
        </p:nvSpPr>
        <p:spPr>
          <a:xfrm>
            <a:off x="5336716" y="1794885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WCL</a:t>
            </a: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25530F47-CF3F-99F9-2516-D70C60813B84}"/>
              </a:ext>
            </a:extLst>
          </p:cNvPr>
          <p:cNvCxnSpPr/>
          <p:nvPr/>
        </p:nvCxnSpPr>
        <p:spPr>
          <a:xfrm>
            <a:off x="4091940" y="1887000"/>
            <a:ext cx="83665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EE2681AF-D51B-27C7-6A89-22F19CC93568}"/>
              </a:ext>
            </a:extLst>
          </p:cNvPr>
          <p:cNvSpPr txBox="1"/>
          <p:nvPr/>
        </p:nvSpPr>
        <p:spPr>
          <a:xfrm>
            <a:off x="3998959" y="1487348"/>
            <a:ext cx="10226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ontrol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74A394FE-AEAC-B54C-BEBC-8AF16748C008}"/>
              </a:ext>
            </a:extLst>
          </p:cNvPr>
          <p:cNvCxnSpPr/>
          <p:nvPr/>
        </p:nvCxnSpPr>
        <p:spPr>
          <a:xfrm>
            <a:off x="7084221" y="1847472"/>
            <a:ext cx="83665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BE9AEF7A-1B43-5A01-3AB7-7AF916929AAA}"/>
              </a:ext>
            </a:extLst>
          </p:cNvPr>
          <p:cNvSpPr txBox="1"/>
          <p:nvPr/>
        </p:nvSpPr>
        <p:spPr>
          <a:xfrm>
            <a:off x="7008839" y="1501363"/>
            <a:ext cx="8366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PA01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D1F2AFCD-DC7D-555E-AA8C-636712573A89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39" t="-269" r="-739" b="52485"/>
          <a:stretch/>
        </p:blipFill>
        <p:spPr>
          <a:xfrm>
            <a:off x="3019118" y="2223118"/>
            <a:ext cx="3076882" cy="1959441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230FAA00-5956-7C09-0518-7FA18B75A95D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45355" b="7267"/>
          <a:stretch/>
        </p:blipFill>
        <p:spPr>
          <a:xfrm>
            <a:off x="6219113" y="2223118"/>
            <a:ext cx="2982298" cy="19594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720581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C2206EC-E979-DEA2-74A5-C216BD03206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B5111CD5-4DA9-7B87-2492-F5EFA5C2C3C2}"/>
              </a:ext>
            </a:extLst>
          </p:cNvPr>
          <p:cNvSpPr txBox="1"/>
          <p:nvPr/>
        </p:nvSpPr>
        <p:spPr>
          <a:xfrm>
            <a:off x="4510267" y="457201"/>
            <a:ext cx="252713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HBEC EV TSG101 WB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704B158-FF7E-A912-F2D7-3ADCAEA8FF24}"/>
              </a:ext>
            </a:extLst>
          </p:cNvPr>
          <p:cNvSpPr txBox="1"/>
          <p:nvPr/>
        </p:nvSpPr>
        <p:spPr>
          <a:xfrm>
            <a:off x="2338086" y="3060197"/>
            <a:ext cx="9935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SG10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B7EC23C-FE08-5AA7-FE34-3DC88F08FE8B}"/>
              </a:ext>
            </a:extLst>
          </p:cNvPr>
          <p:cNvSpPr txBox="1"/>
          <p:nvPr/>
        </p:nvSpPr>
        <p:spPr>
          <a:xfrm>
            <a:off x="8453552" y="3060197"/>
            <a:ext cx="789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47kD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53D3607-FA5D-D502-A442-C7ED9B971BB0}"/>
              </a:ext>
            </a:extLst>
          </p:cNvPr>
          <p:cNvSpPr txBox="1"/>
          <p:nvPr/>
        </p:nvSpPr>
        <p:spPr>
          <a:xfrm>
            <a:off x="3568395" y="1838864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73E09E5-9237-9520-86B4-FEA3DAA974B6}"/>
              </a:ext>
            </a:extLst>
          </p:cNvPr>
          <p:cNvSpPr txBox="1"/>
          <p:nvPr/>
        </p:nvSpPr>
        <p:spPr>
          <a:xfrm>
            <a:off x="3955566" y="1835970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2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EF514A5-E151-5835-CCC2-BE9F93566418}"/>
              </a:ext>
            </a:extLst>
          </p:cNvPr>
          <p:cNvSpPr txBox="1"/>
          <p:nvPr/>
        </p:nvSpPr>
        <p:spPr>
          <a:xfrm>
            <a:off x="6119198" y="1808472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A96AB5C-A794-565A-C6F1-B69D2EF39EBE}"/>
              </a:ext>
            </a:extLst>
          </p:cNvPr>
          <p:cNvSpPr txBox="1"/>
          <p:nvPr/>
        </p:nvSpPr>
        <p:spPr>
          <a:xfrm>
            <a:off x="6523077" y="1812518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833B24C-83BC-2D16-76BC-71CF4A22AF9D}"/>
              </a:ext>
            </a:extLst>
          </p:cNvPr>
          <p:cNvSpPr txBox="1"/>
          <p:nvPr/>
        </p:nvSpPr>
        <p:spPr>
          <a:xfrm>
            <a:off x="5153961" y="1787762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WCL</a:t>
            </a: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6781E3A3-663D-5EDE-D7FA-9EC5E9DA0882}"/>
              </a:ext>
            </a:extLst>
          </p:cNvPr>
          <p:cNvCxnSpPr/>
          <p:nvPr/>
        </p:nvCxnSpPr>
        <p:spPr>
          <a:xfrm>
            <a:off x="3457555" y="1856680"/>
            <a:ext cx="83665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D1DF788A-1B09-4F3E-A83E-6B89D89ADF55}"/>
              </a:ext>
            </a:extLst>
          </p:cNvPr>
          <p:cNvSpPr txBox="1"/>
          <p:nvPr/>
        </p:nvSpPr>
        <p:spPr>
          <a:xfrm>
            <a:off x="3457555" y="1487348"/>
            <a:ext cx="10226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ontrol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A3A08A96-B727-8F30-3BB4-5B979D6F4AEE}"/>
              </a:ext>
            </a:extLst>
          </p:cNvPr>
          <p:cNvCxnSpPr/>
          <p:nvPr/>
        </p:nvCxnSpPr>
        <p:spPr>
          <a:xfrm>
            <a:off x="6200752" y="1822718"/>
            <a:ext cx="83665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23720822-41A0-9AC6-19DF-5E69A8903EF6}"/>
              </a:ext>
            </a:extLst>
          </p:cNvPr>
          <p:cNvSpPr txBox="1"/>
          <p:nvPr/>
        </p:nvSpPr>
        <p:spPr>
          <a:xfrm>
            <a:off x="6072803" y="1465112"/>
            <a:ext cx="8366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PA01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51F3F14C-A324-67AF-BCD0-83F14895881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381" t="53947" b="3405"/>
          <a:stretch/>
        </p:blipFill>
        <p:spPr>
          <a:xfrm>
            <a:off x="3125257" y="2177804"/>
            <a:ext cx="5328295" cy="27067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5324851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B45B899-2A8B-1B8D-064C-76E31BA0467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E228C66E-9B1A-560F-E27D-CBA7988210EE}"/>
              </a:ext>
            </a:extLst>
          </p:cNvPr>
          <p:cNvSpPr txBox="1"/>
          <p:nvPr/>
        </p:nvSpPr>
        <p:spPr>
          <a:xfrm>
            <a:off x="4510267" y="457201"/>
            <a:ext cx="252713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HBEC EV Calnexin WB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B659616-08C8-5F2D-E85E-3A4A1BBE281C}"/>
              </a:ext>
            </a:extLst>
          </p:cNvPr>
          <p:cNvSpPr txBox="1"/>
          <p:nvPr/>
        </p:nvSpPr>
        <p:spPr>
          <a:xfrm>
            <a:off x="2303683" y="2550468"/>
            <a:ext cx="9935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alnexin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D978074-E5C4-A4E2-7F77-EF54BC4F5005}"/>
              </a:ext>
            </a:extLst>
          </p:cNvPr>
          <p:cNvSpPr txBox="1"/>
          <p:nvPr/>
        </p:nvSpPr>
        <p:spPr>
          <a:xfrm>
            <a:off x="9416575" y="2689547"/>
            <a:ext cx="789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90kD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E247AB8-E1A5-9088-CE9C-57F2DFA827FF}"/>
              </a:ext>
            </a:extLst>
          </p:cNvPr>
          <p:cNvSpPr txBox="1"/>
          <p:nvPr/>
        </p:nvSpPr>
        <p:spPr>
          <a:xfrm>
            <a:off x="3705634" y="1978012"/>
            <a:ext cx="4316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21513ED-FE7C-9619-45BE-AA583DA4CD0B}"/>
              </a:ext>
            </a:extLst>
          </p:cNvPr>
          <p:cNvSpPr txBox="1"/>
          <p:nvPr/>
        </p:nvSpPr>
        <p:spPr>
          <a:xfrm>
            <a:off x="4092805" y="1975118"/>
            <a:ext cx="4316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2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C686D5B-AE32-CFEF-4D8E-E92C744CF473}"/>
              </a:ext>
            </a:extLst>
          </p:cNvPr>
          <p:cNvSpPr txBox="1"/>
          <p:nvPr/>
        </p:nvSpPr>
        <p:spPr>
          <a:xfrm>
            <a:off x="6838228" y="1922014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E7D5379-9255-D919-229B-34042B799DB9}"/>
              </a:ext>
            </a:extLst>
          </p:cNvPr>
          <p:cNvSpPr txBox="1"/>
          <p:nvPr/>
        </p:nvSpPr>
        <p:spPr>
          <a:xfrm>
            <a:off x="7124794" y="1922015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2</a:t>
            </a: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195980D3-DA75-84D6-1A89-06E07459C12F}"/>
              </a:ext>
            </a:extLst>
          </p:cNvPr>
          <p:cNvCxnSpPr>
            <a:cxnSpLocks/>
          </p:cNvCxnSpPr>
          <p:nvPr/>
        </p:nvCxnSpPr>
        <p:spPr>
          <a:xfrm>
            <a:off x="3718931" y="2000189"/>
            <a:ext cx="83665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34F38437-520D-7D59-C99B-03039B13B4FA}"/>
              </a:ext>
            </a:extLst>
          </p:cNvPr>
          <p:cNvSpPr txBox="1"/>
          <p:nvPr/>
        </p:nvSpPr>
        <p:spPr>
          <a:xfrm>
            <a:off x="3625950" y="1573701"/>
            <a:ext cx="10226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ontrol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41BE6179-2051-30E4-DE46-3C7AE5AF076F}"/>
              </a:ext>
            </a:extLst>
          </p:cNvPr>
          <p:cNvCxnSpPr/>
          <p:nvPr/>
        </p:nvCxnSpPr>
        <p:spPr>
          <a:xfrm>
            <a:off x="6815612" y="1933847"/>
            <a:ext cx="83665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5CAFC657-FD3C-4183-55EE-8450010CE026}"/>
              </a:ext>
            </a:extLst>
          </p:cNvPr>
          <p:cNvSpPr txBox="1"/>
          <p:nvPr/>
        </p:nvSpPr>
        <p:spPr>
          <a:xfrm>
            <a:off x="6815612" y="1522859"/>
            <a:ext cx="8366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PA01                </a:t>
            </a:r>
          </a:p>
        </p:txBody>
      </p:sp>
      <p:pic>
        <p:nvPicPr>
          <p:cNvPr id="5" name="Picture 4" descr="A white background with black spots&#10;&#10;Description automatically generated">
            <a:extLst>
              <a:ext uri="{FF2B5EF4-FFF2-40B4-BE49-F238E27FC236}">
                <a16:creationId xmlns:a16="http://schemas.microsoft.com/office/drawing/2014/main" id="{17ECB722-FEDE-3173-2C61-B4CB0DBE046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40000" contrast="-40000"/>
                    </a14:imgEffect>
                  </a14:imgLayer>
                </a14:imgProps>
              </a:ext>
            </a:extLst>
          </a:blip>
          <a:srcRect t="15820" b="43863"/>
          <a:stretch/>
        </p:blipFill>
        <p:spPr>
          <a:xfrm>
            <a:off x="3297278" y="2344449"/>
            <a:ext cx="3057618" cy="1798133"/>
          </a:xfrm>
          <a:prstGeom prst="rect">
            <a:avLst/>
          </a:prstGeom>
        </p:spPr>
      </p:pic>
      <p:pic>
        <p:nvPicPr>
          <p:cNvPr id="6" name="Picture 5" descr="A white background with black spots&#10;&#10;Description automatically generated">
            <a:extLst>
              <a:ext uri="{FF2B5EF4-FFF2-40B4-BE49-F238E27FC236}">
                <a16:creationId xmlns:a16="http://schemas.microsoft.com/office/drawing/2014/main" id="{65D0AC66-6C6A-2176-8DC6-415D595546E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40000" contrast="-40000"/>
                    </a14:imgEffect>
                  </a14:imgLayer>
                </a14:imgProps>
              </a:ext>
            </a:extLst>
          </a:blip>
          <a:srcRect t="59024" b="1"/>
          <a:stretch/>
        </p:blipFill>
        <p:spPr>
          <a:xfrm>
            <a:off x="6434277" y="2345264"/>
            <a:ext cx="2982298" cy="1798139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C5715DF9-E132-31AF-3F5F-D8D73EF5F50D}"/>
              </a:ext>
            </a:extLst>
          </p:cNvPr>
          <p:cNvSpPr txBox="1"/>
          <p:nvPr/>
        </p:nvSpPr>
        <p:spPr>
          <a:xfrm>
            <a:off x="8700775" y="1892191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WCL</a:t>
            </a:r>
          </a:p>
        </p:txBody>
      </p:sp>
    </p:spTree>
    <p:extLst>
      <p:ext uri="{BB962C8B-B14F-4D97-AF65-F5344CB8AC3E}">
        <p14:creationId xmlns:p14="http://schemas.microsoft.com/office/powerpoint/2010/main" val="29325579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17E071D-1EF8-796C-1049-DC86DB47F6E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63B517AE-D74E-C1D5-47DC-18EBB5F14CD7}"/>
              </a:ext>
            </a:extLst>
          </p:cNvPr>
          <p:cNvSpPr txBox="1"/>
          <p:nvPr/>
        </p:nvSpPr>
        <p:spPr>
          <a:xfrm>
            <a:off x="4510267" y="457201"/>
            <a:ext cx="252713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 hTCEpi EV CD63 WB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3A32AED-3FC3-F276-6972-0ED2613E3EB7}"/>
              </a:ext>
            </a:extLst>
          </p:cNvPr>
          <p:cNvSpPr txBox="1"/>
          <p:nvPr/>
        </p:nvSpPr>
        <p:spPr>
          <a:xfrm>
            <a:off x="2633923" y="2711005"/>
            <a:ext cx="6977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D63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248851F-7AE6-AE1C-F5CE-D6BCF7F42D2E}"/>
              </a:ext>
            </a:extLst>
          </p:cNvPr>
          <p:cNvSpPr txBox="1"/>
          <p:nvPr/>
        </p:nvSpPr>
        <p:spPr>
          <a:xfrm>
            <a:off x="3568395" y="1838864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2E61905-446B-E761-B04F-D6EB4F53AB19}"/>
              </a:ext>
            </a:extLst>
          </p:cNvPr>
          <p:cNvSpPr txBox="1"/>
          <p:nvPr/>
        </p:nvSpPr>
        <p:spPr>
          <a:xfrm>
            <a:off x="3955566" y="1835970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2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9AAD829-E21D-98BB-CAA3-F16D9C00CF79}"/>
              </a:ext>
            </a:extLst>
          </p:cNvPr>
          <p:cNvSpPr txBox="1"/>
          <p:nvPr/>
        </p:nvSpPr>
        <p:spPr>
          <a:xfrm>
            <a:off x="6388093" y="1854819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374B0A2-2622-8F34-4475-E48E81185086}"/>
              </a:ext>
            </a:extLst>
          </p:cNvPr>
          <p:cNvSpPr txBox="1"/>
          <p:nvPr/>
        </p:nvSpPr>
        <p:spPr>
          <a:xfrm>
            <a:off x="6782981" y="1859149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C8E88C9-2444-7388-45DD-667C4D5FE5FA}"/>
              </a:ext>
            </a:extLst>
          </p:cNvPr>
          <p:cNvSpPr txBox="1"/>
          <p:nvPr/>
        </p:nvSpPr>
        <p:spPr>
          <a:xfrm>
            <a:off x="5228106" y="1838864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WCL</a:t>
            </a: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4CBE0E0E-578F-CC6D-F549-3CB4831D8C20}"/>
              </a:ext>
            </a:extLst>
          </p:cNvPr>
          <p:cNvCxnSpPr/>
          <p:nvPr/>
        </p:nvCxnSpPr>
        <p:spPr>
          <a:xfrm>
            <a:off x="3457555" y="1856680"/>
            <a:ext cx="83665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5C35BD5E-3E3D-E6AE-9C8F-79C91EDD662F}"/>
              </a:ext>
            </a:extLst>
          </p:cNvPr>
          <p:cNvSpPr txBox="1"/>
          <p:nvPr/>
        </p:nvSpPr>
        <p:spPr>
          <a:xfrm>
            <a:off x="3457555" y="1487348"/>
            <a:ext cx="10226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ontrol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DDF70C45-0FDE-3FBC-595F-76AACA2558C6}"/>
              </a:ext>
            </a:extLst>
          </p:cNvPr>
          <p:cNvCxnSpPr/>
          <p:nvPr/>
        </p:nvCxnSpPr>
        <p:spPr>
          <a:xfrm>
            <a:off x="6462919" y="1832630"/>
            <a:ext cx="83665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0A9AED8A-5B16-6ADE-5423-267BA23D3EB6}"/>
              </a:ext>
            </a:extLst>
          </p:cNvPr>
          <p:cNvSpPr txBox="1"/>
          <p:nvPr/>
        </p:nvSpPr>
        <p:spPr>
          <a:xfrm>
            <a:off x="6364654" y="1481026"/>
            <a:ext cx="8366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PA01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6EB4F711-DC35-8895-4F8D-ED8B8BEF75D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</a:extLst>
          </a:blip>
          <a:srcRect l="14562" t="9066" r="7728" b="55829"/>
          <a:stretch/>
        </p:blipFill>
        <p:spPr>
          <a:xfrm>
            <a:off x="3331681" y="2196379"/>
            <a:ext cx="2953289" cy="1749067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46C87F94-F5FD-3B2D-9B7C-141DB301D80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rcRect l="11804" t="61669" r="21442" b="7708"/>
          <a:stretch/>
        </p:blipFill>
        <p:spPr>
          <a:xfrm>
            <a:off x="6360263" y="2215228"/>
            <a:ext cx="2876889" cy="1730218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A4E0612F-FD2F-F010-22B8-95EF295C2D92}"/>
              </a:ext>
            </a:extLst>
          </p:cNvPr>
          <p:cNvSpPr txBox="1"/>
          <p:nvPr/>
        </p:nvSpPr>
        <p:spPr>
          <a:xfrm>
            <a:off x="9219095" y="2778982"/>
            <a:ext cx="789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60kDa</a:t>
            </a:r>
          </a:p>
        </p:txBody>
      </p:sp>
    </p:spTree>
    <p:extLst>
      <p:ext uri="{BB962C8B-B14F-4D97-AF65-F5344CB8AC3E}">
        <p14:creationId xmlns:p14="http://schemas.microsoft.com/office/powerpoint/2010/main" val="40863936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17E071D-1EF8-796C-1049-DC86DB47F6E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63B517AE-D74E-C1D5-47DC-18EBB5F14CD7}"/>
              </a:ext>
            </a:extLst>
          </p:cNvPr>
          <p:cNvSpPr txBox="1"/>
          <p:nvPr/>
        </p:nvSpPr>
        <p:spPr>
          <a:xfrm>
            <a:off x="4510267" y="457201"/>
            <a:ext cx="252713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 hTCEpi EV CD81 WB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3A32AED-3FC3-F276-6972-0ED2613E3EB7}"/>
              </a:ext>
            </a:extLst>
          </p:cNvPr>
          <p:cNvSpPr txBox="1"/>
          <p:nvPr/>
        </p:nvSpPr>
        <p:spPr>
          <a:xfrm>
            <a:off x="2574983" y="3346541"/>
            <a:ext cx="6977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D8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248851F-7AE6-AE1C-F5CE-D6BCF7F42D2E}"/>
              </a:ext>
            </a:extLst>
          </p:cNvPr>
          <p:cNvSpPr txBox="1"/>
          <p:nvPr/>
        </p:nvSpPr>
        <p:spPr>
          <a:xfrm>
            <a:off x="3968862" y="1913471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2E61905-446B-E761-B04F-D6EB4F53AB19}"/>
              </a:ext>
            </a:extLst>
          </p:cNvPr>
          <p:cNvSpPr txBox="1"/>
          <p:nvPr/>
        </p:nvSpPr>
        <p:spPr>
          <a:xfrm>
            <a:off x="4305322" y="1906791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2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9AAD829-E21D-98BB-CAA3-F16D9C00CF79}"/>
              </a:ext>
            </a:extLst>
          </p:cNvPr>
          <p:cNvSpPr txBox="1"/>
          <p:nvPr/>
        </p:nvSpPr>
        <p:spPr>
          <a:xfrm>
            <a:off x="6782981" y="1894833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374B0A2-2622-8F34-4475-E48E81185086}"/>
              </a:ext>
            </a:extLst>
          </p:cNvPr>
          <p:cNvSpPr txBox="1"/>
          <p:nvPr/>
        </p:nvSpPr>
        <p:spPr>
          <a:xfrm>
            <a:off x="7067017" y="1901046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C8E88C9-2444-7388-45DD-667C4D5FE5FA}"/>
              </a:ext>
            </a:extLst>
          </p:cNvPr>
          <p:cNvSpPr txBox="1"/>
          <p:nvPr/>
        </p:nvSpPr>
        <p:spPr>
          <a:xfrm>
            <a:off x="5476224" y="1913471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WCL</a:t>
            </a: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4CBE0E0E-578F-CC6D-F549-3CB4831D8C20}"/>
              </a:ext>
            </a:extLst>
          </p:cNvPr>
          <p:cNvCxnSpPr/>
          <p:nvPr/>
        </p:nvCxnSpPr>
        <p:spPr>
          <a:xfrm>
            <a:off x="4091940" y="1909820"/>
            <a:ext cx="83665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5C35BD5E-3E3D-E6AE-9C8F-79C91EDD662F}"/>
              </a:ext>
            </a:extLst>
          </p:cNvPr>
          <p:cNvSpPr txBox="1"/>
          <p:nvPr/>
        </p:nvSpPr>
        <p:spPr>
          <a:xfrm>
            <a:off x="4039391" y="1553717"/>
            <a:ext cx="10226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ontrol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DDF70C45-0FDE-3FBC-595F-76AACA2558C6}"/>
              </a:ext>
            </a:extLst>
          </p:cNvPr>
          <p:cNvCxnSpPr/>
          <p:nvPr/>
        </p:nvCxnSpPr>
        <p:spPr>
          <a:xfrm>
            <a:off x="6799712" y="1866839"/>
            <a:ext cx="83665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0A9AED8A-5B16-6ADE-5423-267BA23D3EB6}"/>
              </a:ext>
            </a:extLst>
          </p:cNvPr>
          <p:cNvSpPr txBox="1"/>
          <p:nvPr/>
        </p:nvSpPr>
        <p:spPr>
          <a:xfrm>
            <a:off x="6799712" y="1497507"/>
            <a:ext cx="8366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PA0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4E0612F-FD2F-F010-22B8-95EF295C2D92}"/>
              </a:ext>
            </a:extLst>
          </p:cNvPr>
          <p:cNvSpPr txBox="1"/>
          <p:nvPr/>
        </p:nvSpPr>
        <p:spPr>
          <a:xfrm>
            <a:off x="8581804" y="3346541"/>
            <a:ext cx="789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20kDa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4B9CA2E2-0E86-7A46-8E25-DBCF09C808C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5472" b="61073"/>
          <a:stretch/>
        </p:blipFill>
        <p:spPr>
          <a:xfrm>
            <a:off x="3272741" y="2300908"/>
            <a:ext cx="2785911" cy="1577475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8925EDE0-2056-D9B8-6CF9-29938300177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 contrast="20000"/>
                    </a14:imgEffect>
                  </a14:imgLayer>
                </a14:imgProps>
              </a:ext>
            </a:extLst>
          </a:blip>
          <a:srcRect l="3640" t="50000" r="689" b="6667"/>
          <a:stretch/>
        </p:blipFill>
        <p:spPr>
          <a:xfrm>
            <a:off x="6133350" y="2292158"/>
            <a:ext cx="2532888" cy="15862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815449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17E071D-1EF8-796C-1049-DC86DB47F6E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63B517AE-D74E-C1D5-47DC-18EBB5F14CD7}"/>
              </a:ext>
            </a:extLst>
          </p:cNvPr>
          <p:cNvSpPr txBox="1"/>
          <p:nvPr/>
        </p:nvSpPr>
        <p:spPr>
          <a:xfrm>
            <a:off x="4510267" y="457201"/>
            <a:ext cx="252713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 hTCEpi EV Flotillin WB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3A32AED-3FC3-F276-6972-0ED2613E3EB7}"/>
              </a:ext>
            </a:extLst>
          </p:cNvPr>
          <p:cNvSpPr txBox="1"/>
          <p:nvPr/>
        </p:nvSpPr>
        <p:spPr>
          <a:xfrm>
            <a:off x="2036511" y="2797130"/>
            <a:ext cx="9578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lotillin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248851F-7AE6-AE1C-F5CE-D6BCF7F42D2E}"/>
              </a:ext>
            </a:extLst>
          </p:cNvPr>
          <p:cNvSpPr txBox="1"/>
          <p:nvPr/>
        </p:nvSpPr>
        <p:spPr>
          <a:xfrm>
            <a:off x="3568395" y="1838864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2E61905-446B-E761-B04F-D6EB4F53AB19}"/>
              </a:ext>
            </a:extLst>
          </p:cNvPr>
          <p:cNvSpPr txBox="1"/>
          <p:nvPr/>
        </p:nvSpPr>
        <p:spPr>
          <a:xfrm>
            <a:off x="3955566" y="1835970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2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9AAD829-E21D-98BB-CAA3-F16D9C00CF79}"/>
              </a:ext>
            </a:extLst>
          </p:cNvPr>
          <p:cNvSpPr txBox="1"/>
          <p:nvPr/>
        </p:nvSpPr>
        <p:spPr>
          <a:xfrm>
            <a:off x="6520566" y="1852531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374B0A2-2622-8F34-4475-E48E81185086}"/>
              </a:ext>
            </a:extLst>
          </p:cNvPr>
          <p:cNvSpPr txBox="1"/>
          <p:nvPr/>
        </p:nvSpPr>
        <p:spPr>
          <a:xfrm>
            <a:off x="6891241" y="1860106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C8E88C9-2444-7388-45DD-667C4D5FE5FA}"/>
              </a:ext>
            </a:extLst>
          </p:cNvPr>
          <p:cNvSpPr txBox="1"/>
          <p:nvPr/>
        </p:nvSpPr>
        <p:spPr>
          <a:xfrm>
            <a:off x="7977916" y="1831613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WCL</a:t>
            </a: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4CBE0E0E-578F-CC6D-F549-3CB4831D8C20}"/>
              </a:ext>
            </a:extLst>
          </p:cNvPr>
          <p:cNvCxnSpPr/>
          <p:nvPr/>
        </p:nvCxnSpPr>
        <p:spPr>
          <a:xfrm>
            <a:off x="3457555" y="1856680"/>
            <a:ext cx="83665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5C35BD5E-3E3D-E6AE-9C8F-79C91EDD662F}"/>
              </a:ext>
            </a:extLst>
          </p:cNvPr>
          <p:cNvSpPr txBox="1"/>
          <p:nvPr/>
        </p:nvSpPr>
        <p:spPr>
          <a:xfrm>
            <a:off x="3457555" y="1487348"/>
            <a:ext cx="10226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ontrol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DDF70C45-0FDE-3FBC-595F-76AACA2558C6}"/>
              </a:ext>
            </a:extLst>
          </p:cNvPr>
          <p:cNvCxnSpPr/>
          <p:nvPr/>
        </p:nvCxnSpPr>
        <p:spPr>
          <a:xfrm>
            <a:off x="6462919" y="1832630"/>
            <a:ext cx="83665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0A9AED8A-5B16-6ADE-5423-267BA23D3EB6}"/>
              </a:ext>
            </a:extLst>
          </p:cNvPr>
          <p:cNvSpPr txBox="1"/>
          <p:nvPr/>
        </p:nvSpPr>
        <p:spPr>
          <a:xfrm>
            <a:off x="6364654" y="1481026"/>
            <a:ext cx="8366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PA0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4E0612F-FD2F-F010-22B8-95EF295C2D92}"/>
              </a:ext>
            </a:extLst>
          </p:cNvPr>
          <p:cNvSpPr txBox="1"/>
          <p:nvPr/>
        </p:nvSpPr>
        <p:spPr>
          <a:xfrm>
            <a:off x="8886789" y="2870518"/>
            <a:ext cx="789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48kDa</a:t>
            </a:r>
          </a:p>
        </p:txBody>
      </p:sp>
      <p:pic>
        <p:nvPicPr>
          <p:cNvPr id="4" name="Picture 3" descr="A close-up of a white sheet&#10;&#10;Description automatically generated">
            <a:extLst>
              <a:ext uri="{FF2B5EF4-FFF2-40B4-BE49-F238E27FC236}">
                <a16:creationId xmlns:a16="http://schemas.microsoft.com/office/drawing/2014/main" id="{79B3EACE-BE84-C87E-DD4E-FA850D67BDF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40000" contrast="-40000"/>
                    </a14:imgEffect>
                  </a14:imgLayer>
                </a14:imgProps>
              </a:ext>
            </a:extLst>
          </a:blip>
          <a:srcRect b="53475"/>
          <a:stretch/>
        </p:blipFill>
        <p:spPr>
          <a:xfrm>
            <a:off x="2902953" y="2205302"/>
            <a:ext cx="2981992" cy="1907627"/>
          </a:xfrm>
          <a:prstGeom prst="rect">
            <a:avLst/>
          </a:prstGeom>
        </p:spPr>
      </p:pic>
      <p:pic>
        <p:nvPicPr>
          <p:cNvPr id="7" name="Picture 6" descr="A close-up of a white sheet&#10;&#10;Description automatically generated">
            <a:extLst>
              <a:ext uri="{FF2B5EF4-FFF2-40B4-BE49-F238E27FC236}">
                <a16:creationId xmlns:a16="http://schemas.microsoft.com/office/drawing/2014/main" id="{0E4DE167-D69F-54B4-4766-AA565C2209E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40000" contrast="-40000"/>
                    </a14:imgEffect>
                  </a14:imgLayer>
                </a14:imgProps>
              </a:ext>
            </a:extLst>
          </a:blip>
          <a:srcRect t="53475"/>
          <a:stretch/>
        </p:blipFill>
        <p:spPr>
          <a:xfrm>
            <a:off x="5904797" y="2200945"/>
            <a:ext cx="2981992" cy="19076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1206530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17E071D-1EF8-796C-1049-DC86DB47F6E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63B517AE-D74E-C1D5-47DC-18EBB5F14CD7}"/>
              </a:ext>
            </a:extLst>
          </p:cNvPr>
          <p:cNvSpPr txBox="1"/>
          <p:nvPr/>
        </p:nvSpPr>
        <p:spPr>
          <a:xfrm>
            <a:off x="4510267" y="457201"/>
            <a:ext cx="252713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 hTCEpi EV TSG101 WB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3A32AED-3FC3-F276-6972-0ED2613E3EB7}"/>
              </a:ext>
            </a:extLst>
          </p:cNvPr>
          <p:cNvSpPr txBox="1"/>
          <p:nvPr/>
        </p:nvSpPr>
        <p:spPr>
          <a:xfrm>
            <a:off x="2525512" y="2835219"/>
            <a:ext cx="9578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SG10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248851F-7AE6-AE1C-F5CE-D6BCF7F42D2E}"/>
              </a:ext>
            </a:extLst>
          </p:cNvPr>
          <p:cNvSpPr txBox="1"/>
          <p:nvPr/>
        </p:nvSpPr>
        <p:spPr>
          <a:xfrm>
            <a:off x="3568395" y="1838864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2E61905-446B-E761-B04F-D6EB4F53AB19}"/>
              </a:ext>
            </a:extLst>
          </p:cNvPr>
          <p:cNvSpPr txBox="1"/>
          <p:nvPr/>
        </p:nvSpPr>
        <p:spPr>
          <a:xfrm>
            <a:off x="3955566" y="1835970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2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9AAD829-E21D-98BB-CAA3-F16D9C00CF79}"/>
              </a:ext>
            </a:extLst>
          </p:cNvPr>
          <p:cNvSpPr txBox="1"/>
          <p:nvPr/>
        </p:nvSpPr>
        <p:spPr>
          <a:xfrm>
            <a:off x="6388093" y="1854819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374B0A2-2622-8F34-4475-E48E81185086}"/>
              </a:ext>
            </a:extLst>
          </p:cNvPr>
          <p:cNvSpPr txBox="1"/>
          <p:nvPr/>
        </p:nvSpPr>
        <p:spPr>
          <a:xfrm>
            <a:off x="6782981" y="1859149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C8E88C9-2444-7388-45DD-667C4D5FE5FA}"/>
              </a:ext>
            </a:extLst>
          </p:cNvPr>
          <p:cNvSpPr txBox="1"/>
          <p:nvPr/>
        </p:nvSpPr>
        <p:spPr>
          <a:xfrm>
            <a:off x="5228106" y="1838864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WCL</a:t>
            </a: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4CBE0E0E-578F-CC6D-F549-3CB4831D8C20}"/>
              </a:ext>
            </a:extLst>
          </p:cNvPr>
          <p:cNvCxnSpPr/>
          <p:nvPr/>
        </p:nvCxnSpPr>
        <p:spPr>
          <a:xfrm>
            <a:off x="3457555" y="1856680"/>
            <a:ext cx="83665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5C35BD5E-3E3D-E6AE-9C8F-79C91EDD662F}"/>
              </a:ext>
            </a:extLst>
          </p:cNvPr>
          <p:cNvSpPr txBox="1"/>
          <p:nvPr/>
        </p:nvSpPr>
        <p:spPr>
          <a:xfrm>
            <a:off x="3457555" y="1487348"/>
            <a:ext cx="10226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ontrol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DDF70C45-0FDE-3FBC-595F-76AACA2558C6}"/>
              </a:ext>
            </a:extLst>
          </p:cNvPr>
          <p:cNvCxnSpPr/>
          <p:nvPr/>
        </p:nvCxnSpPr>
        <p:spPr>
          <a:xfrm>
            <a:off x="6462919" y="1832630"/>
            <a:ext cx="83665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0A9AED8A-5B16-6ADE-5423-267BA23D3EB6}"/>
              </a:ext>
            </a:extLst>
          </p:cNvPr>
          <p:cNvSpPr txBox="1"/>
          <p:nvPr/>
        </p:nvSpPr>
        <p:spPr>
          <a:xfrm>
            <a:off x="6364654" y="1481026"/>
            <a:ext cx="8366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PA0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4E0612F-FD2F-F010-22B8-95EF295C2D92}"/>
              </a:ext>
            </a:extLst>
          </p:cNvPr>
          <p:cNvSpPr txBox="1"/>
          <p:nvPr/>
        </p:nvSpPr>
        <p:spPr>
          <a:xfrm>
            <a:off x="8906641" y="2685852"/>
            <a:ext cx="789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47kDa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99E7A19-7B66-616F-45D6-CBB6A8D7462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40000" contrast="-40000"/>
                    </a14:imgEffect>
                  </a14:imgLayer>
                </a14:imgProps>
              </a:ext>
            </a:extLst>
          </a:blip>
          <a:srcRect l="11998" r="9828" b="51593"/>
          <a:stretch/>
        </p:blipFill>
        <p:spPr>
          <a:xfrm>
            <a:off x="3367841" y="2174404"/>
            <a:ext cx="2405995" cy="1770528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1CC4C7FB-C5E9-7CC5-02E3-7A91139E01E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40000" contrast="-40000"/>
                    </a14:imgEffect>
                  </a14:imgLayer>
                </a14:imgProps>
              </a:ext>
            </a:extLst>
          </a:blip>
          <a:srcRect l="14313" t="51348" r="14854"/>
          <a:stretch/>
        </p:blipFill>
        <p:spPr>
          <a:xfrm>
            <a:off x="6384795" y="2119278"/>
            <a:ext cx="2578189" cy="17794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9516565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B45B899-2A8B-1B8D-064C-76E31BA0467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E228C66E-9B1A-560F-E27D-CBA7988210EE}"/>
              </a:ext>
            </a:extLst>
          </p:cNvPr>
          <p:cNvSpPr txBox="1"/>
          <p:nvPr/>
        </p:nvSpPr>
        <p:spPr>
          <a:xfrm>
            <a:off x="4510267" y="457201"/>
            <a:ext cx="252713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hTCEpi EV Calnexin WB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B659616-08C8-5F2D-E85E-3A4A1BBE281C}"/>
              </a:ext>
            </a:extLst>
          </p:cNvPr>
          <p:cNvSpPr txBox="1"/>
          <p:nvPr/>
        </p:nvSpPr>
        <p:spPr>
          <a:xfrm>
            <a:off x="2303683" y="2550468"/>
            <a:ext cx="9935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alnexin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D978074-E5C4-A4E2-7F77-EF54BC4F5005}"/>
              </a:ext>
            </a:extLst>
          </p:cNvPr>
          <p:cNvSpPr txBox="1"/>
          <p:nvPr/>
        </p:nvSpPr>
        <p:spPr>
          <a:xfrm>
            <a:off x="9664212" y="2735134"/>
            <a:ext cx="789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90kD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E247AB8-E1A5-9088-CE9C-57F2DFA827FF}"/>
              </a:ext>
            </a:extLst>
          </p:cNvPr>
          <p:cNvSpPr txBox="1"/>
          <p:nvPr/>
        </p:nvSpPr>
        <p:spPr>
          <a:xfrm>
            <a:off x="3705634" y="1978012"/>
            <a:ext cx="4316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21513ED-FE7C-9619-45BE-AA583DA4CD0B}"/>
              </a:ext>
            </a:extLst>
          </p:cNvPr>
          <p:cNvSpPr txBox="1"/>
          <p:nvPr/>
        </p:nvSpPr>
        <p:spPr>
          <a:xfrm>
            <a:off x="4092805" y="1975118"/>
            <a:ext cx="4316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2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C686D5B-AE32-CFEF-4D8E-E92C744CF473}"/>
              </a:ext>
            </a:extLst>
          </p:cNvPr>
          <p:cNvSpPr txBox="1"/>
          <p:nvPr/>
        </p:nvSpPr>
        <p:spPr>
          <a:xfrm>
            <a:off x="6838228" y="1922014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E7D5379-9255-D919-229B-34042B799DB9}"/>
              </a:ext>
            </a:extLst>
          </p:cNvPr>
          <p:cNvSpPr txBox="1"/>
          <p:nvPr/>
        </p:nvSpPr>
        <p:spPr>
          <a:xfrm>
            <a:off x="7124794" y="1922015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2</a:t>
            </a: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195980D3-DA75-84D6-1A89-06E07459C12F}"/>
              </a:ext>
            </a:extLst>
          </p:cNvPr>
          <p:cNvCxnSpPr>
            <a:cxnSpLocks/>
          </p:cNvCxnSpPr>
          <p:nvPr/>
        </p:nvCxnSpPr>
        <p:spPr>
          <a:xfrm>
            <a:off x="3718931" y="2000189"/>
            <a:ext cx="83665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34F38437-520D-7D59-C99B-03039B13B4FA}"/>
              </a:ext>
            </a:extLst>
          </p:cNvPr>
          <p:cNvSpPr txBox="1"/>
          <p:nvPr/>
        </p:nvSpPr>
        <p:spPr>
          <a:xfrm>
            <a:off x="3625950" y="1573701"/>
            <a:ext cx="10226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ontrol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41BE6179-2051-30E4-DE46-3C7AE5AF076F}"/>
              </a:ext>
            </a:extLst>
          </p:cNvPr>
          <p:cNvCxnSpPr/>
          <p:nvPr/>
        </p:nvCxnSpPr>
        <p:spPr>
          <a:xfrm>
            <a:off x="6815612" y="1933847"/>
            <a:ext cx="83665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5CAFC657-FD3C-4183-55EE-8450010CE026}"/>
              </a:ext>
            </a:extLst>
          </p:cNvPr>
          <p:cNvSpPr txBox="1"/>
          <p:nvPr/>
        </p:nvSpPr>
        <p:spPr>
          <a:xfrm>
            <a:off x="6815612" y="1522859"/>
            <a:ext cx="8366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PA01                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EB4B5E34-958D-825B-0D6F-416EBF7A4CC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40000" contrast="40000"/>
                    </a14:imgEffect>
                  </a14:imgLayer>
                </a14:imgProps>
              </a:ext>
            </a:extLst>
          </a:blip>
          <a:srcRect t="7488" b="50493"/>
          <a:stretch/>
        </p:blipFill>
        <p:spPr>
          <a:xfrm>
            <a:off x="3287825" y="2366627"/>
            <a:ext cx="3040222" cy="1756512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C5715DF9-E132-31AF-3F5F-D8D73EF5F50D}"/>
              </a:ext>
            </a:extLst>
          </p:cNvPr>
          <p:cNvSpPr txBox="1"/>
          <p:nvPr/>
        </p:nvSpPr>
        <p:spPr>
          <a:xfrm>
            <a:off x="8616692" y="1892191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WCL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DAF7F0EE-8921-DEF8-0FF0-72106D1177F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40000" contrast="40000"/>
                    </a14:imgEffect>
                  </a14:imgLayer>
                </a14:imgProps>
              </a:ext>
            </a:extLst>
          </a:blip>
          <a:srcRect t="57981"/>
          <a:stretch/>
        </p:blipFill>
        <p:spPr>
          <a:xfrm>
            <a:off x="6385805" y="2366627"/>
            <a:ext cx="3220649" cy="17565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1568770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505652F4-986D-1728-FA9A-6B00DA4C7A5A}"/>
              </a:ext>
            </a:extLst>
          </p:cNvPr>
          <p:cNvSpPr txBox="1"/>
          <p:nvPr/>
        </p:nvSpPr>
        <p:spPr>
          <a:xfrm>
            <a:off x="4510267" y="457201"/>
            <a:ext cx="252713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HBEC EV CD9 WB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AF6AA16-3AC0-55CC-2EE2-A2B54D86AB90}"/>
              </a:ext>
            </a:extLst>
          </p:cNvPr>
          <p:cNvSpPr txBox="1"/>
          <p:nvPr/>
        </p:nvSpPr>
        <p:spPr>
          <a:xfrm>
            <a:off x="1841537" y="4433106"/>
            <a:ext cx="6354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D9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7E623DD-1CEA-4C09-E03F-D7C89DFB9804}"/>
              </a:ext>
            </a:extLst>
          </p:cNvPr>
          <p:cNvSpPr txBox="1"/>
          <p:nvPr/>
        </p:nvSpPr>
        <p:spPr>
          <a:xfrm>
            <a:off x="8017504" y="4502553"/>
            <a:ext cx="789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8kD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23B7102-EC9B-F84C-2DB9-DB42D2CDDFEA}"/>
              </a:ext>
            </a:extLst>
          </p:cNvPr>
          <p:cNvSpPr txBox="1"/>
          <p:nvPr/>
        </p:nvSpPr>
        <p:spPr>
          <a:xfrm>
            <a:off x="3558208" y="1809329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B49FFAD-E7AF-8A95-83D5-006A66D9465D}"/>
              </a:ext>
            </a:extLst>
          </p:cNvPr>
          <p:cNvSpPr txBox="1"/>
          <p:nvPr/>
        </p:nvSpPr>
        <p:spPr>
          <a:xfrm>
            <a:off x="3945379" y="1806435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2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F2AC167-C652-F150-6811-242D376BCDBE}"/>
              </a:ext>
            </a:extLst>
          </p:cNvPr>
          <p:cNvSpPr txBox="1"/>
          <p:nvPr/>
        </p:nvSpPr>
        <p:spPr>
          <a:xfrm>
            <a:off x="5769650" y="1883140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046A71D-AAF6-1DF8-9327-4B3DDCAA82E5}"/>
              </a:ext>
            </a:extLst>
          </p:cNvPr>
          <p:cNvSpPr txBox="1"/>
          <p:nvPr/>
        </p:nvSpPr>
        <p:spPr>
          <a:xfrm>
            <a:off x="6164538" y="1887470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A15DA47-70FA-58FF-399C-A041ABFC3F96}"/>
              </a:ext>
            </a:extLst>
          </p:cNvPr>
          <p:cNvSpPr txBox="1"/>
          <p:nvPr/>
        </p:nvSpPr>
        <p:spPr>
          <a:xfrm>
            <a:off x="4812231" y="1824323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WCL</a:t>
            </a: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6121E24A-9125-5052-CD08-E27BFE4624E4}"/>
              </a:ext>
            </a:extLst>
          </p:cNvPr>
          <p:cNvCxnSpPr/>
          <p:nvPr/>
        </p:nvCxnSpPr>
        <p:spPr>
          <a:xfrm>
            <a:off x="3558208" y="1838792"/>
            <a:ext cx="83665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6FDD60EB-7D23-D4F7-8ABF-2363609F0034}"/>
              </a:ext>
            </a:extLst>
          </p:cNvPr>
          <p:cNvSpPr txBox="1"/>
          <p:nvPr/>
        </p:nvSpPr>
        <p:spPr>
          <a:xfrm>
            <a:off x="3558208" y="1448750"/>
            <a:ext cx="10226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ontrol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90DE5743-B81E-D82D-9D32-31ED68801729}"/>
              </a:ext>
            </a:extLst>
          </p:cNvPr>
          <p:cNvCxnSpPr/>
          <p:nvPr/>
        </p:nvCxnSpPr>
        <p:spPr>
          <a:xfrm>
            <a:off x="5721712" y="1901685"/>
            <a:ext cx="83665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AF4AC858-5349-C74A-0746-563D656F1FF7}"/>
              </a:ext>
            </a:extLst>
          </p:cNvPr>
          <p:cNvSpPr txBox="1"/>
          <p:nvPr/>
        </p:nvSpPr>
        <p:spPr>
          <a:xfrm>
            <a:off x="5721712" y="1511643"/>
            <a:ext cx="10226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PA01</a:t>
            </a:r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931EC752-EF0B-2215-369A-DFC24043832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499" t="5762" b="52474"/>
          <a:stretch/>
        </p:blipFill>
        <p:spPr>
          <a:xfrm>
            <a:off x="2476982" y="2193655"/>
            <a:ext cx="5540522" cy="32256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0714526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17E071D-1EF8-796C-1049-DC86DB47F6E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63B517AE-D74E-C1D5-47DC-18EBB5F14CD7}"/>
              </a:ext>
            </a:extLst>
          </p:cNvPr>
          <p:cNvSpPr txBox="1"/>
          <p:nvPr/>
        </p:nvSpPr>
        <p:spPr>
          <a:xfrm>
            <a:off x="4510267" y="457201"/>
            <a:ext cx="252713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HBEC EV CD63 WB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3A32AED-3FC3-F276-6972-0ED2613E3EB7}"/>
              </a:ext>
            </a:extLst>
          </p:cNvPr>
          <p:cNvSpPr txBox="1"/>
          <p:nvPr/>
        </p:nvSpPr>
        <p:spPr>
          <a:xfrm>
            <a:off x="2633923" y="3060197"/>
            <a:ext cx="6977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D63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18B40B6-3EB0-8945-13F0-884F350167B1}"/>
              </a:ext>
            </a:extLst>
          </p:cNvPr>
          <p:cNvSpPr txBox="1"/>
          <p:nvPr/>
        </p:nvSpPr>
        <p:spPr>
          <a:xfrm>
            <a:off x="8588415" y="2963648"/>
            <a:ext cx="789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60kD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248851F-7AE6-AE1C-F5CE-D6BCF7F42D2E}"/>
              </a:ext>
            </a:extLst>
          </p:cNvPr>
          <p:cNvSpPr txBox="1"/>
          <p:nvPr/>
        </p:nvSpPr>
        <p:spPr>
          <a:xfrm>
            <a:off x="3568395" y="1838864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2E61905-446B-E761-B04F-D6EB4F53AB19}"/>
              </a:ext>
            </a:extLst>
          </p:cNvPr>
          <p:cNvSpPr txBox="1"/>
          <p:nvPr/>
        </p:nvSpPr>
        <p:spPr>
          <a:xfrm>
            <a:off x="3955566" y="1835970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2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9AAD829-E21D-98BB-CAA3-F16D9C00CF79}"/>
              </a:ext>
            </a:extLst>
          </p:cNvPr>
          <p:cNvSpPr txBox="1"/>
          <p:nvPr/>
        </p:nvSpPr>
        <p:spPr>
          <a:xfrm>
            <a:off x="5679658" y="1809465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374B0A2-2622-8F34-4475-E48E81185086}"/>
              </a:ext>
            </a:extLst>
          </p:cNvPr>
          <p:cNvSpPr txBox="1"/>
          <p:nvPr/>
        </p:nvSpPr>
        <p:spPr>
          <a:xfrm>
            <a:off x="6074546" y="1813795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C8E88C9-2444-7388-45DD-667C4D5FE5FA}"/>
              </a:ext>
            </a:extLst>
          </p:cNvPr>
          <p:cNvSpPr txBox="1"/>
          <p:nvPr/>
        </p:nvSpPr>
        <p:spPr>
          <a:xfrm>
            <a:off x="5153961" y="1787762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WCL</a:t>
            </a: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4CBE0E0E-578F-CC6D-F549-3CB4831D8C20}"/>
              </a:ext>
            </a:extLst>
          </p:cNvPr>
          <p:cNvCxnSpPr/>
          <p:nvPr/>
        </p:nvCxnSpPr>
        <p:spPr>
          <a:xfrm>
            <a:off x="3457555" y="1856680"/>
            <a:ext cx="83665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5C35BD5E-3E3D-E6AE-9C8F-79C91EDD662F}"/>
              </a:ext>
            </a:extLst>
          </p:cNvPr>
          <p:cNvSpPr txBox="1"/>
          <p:nvPr/>
        </p:nvSpPr>
        <p:spPr>
          <a:xfrm>
            <a:off x="3457555" y="1487348"/>
            <a:ext cx="10226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ontrol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DDF70C45-0FDE-3FBC-595F-76AACA2558C6}"/>
              </a:ext>
            </a:extLst>
          </p:cNvPr>
          <p:cNvCxnSpPr/>
          <p:nvPr/>
        </p:nvCxnSpPr>
        <p:spPr>
          <a:xfrm>
            <a:off x="5689444" y="1835970"/>
            <a:ext cx="83665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0A9AED8A-5B16-6ADE-5423-267BA23D3EB6}"/>
              </a:ext>
            </a:extLst>
          </p:cNvPr>
          <p:cNvSpPr txBox="1"/>
          <p:nvPr/>
        </p:nvSpPr>
        <p:spPr>
          <a:xfrm>
            <a:off x="5689444" y="1453386"/>
            <a:ext cx="8366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PA01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1656E34-A85B-5815-5B26-455CB42664C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</a:extLst>
          </a:blip>
          <a:srcRect l="5696" t="34637" r="2643" b="22058"/>
          <a:stretch/>
        </p:blipFill>
        <p:spPr>
          <a:xfrm>
            <a:off x="3258955" y="2143662"/>
            <a:ext cx="5329460" cy="30904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949036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73D1DA2-309D-96E5-0C99-A28FF7487CC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DEC533A2-5901-400F-F518-D3D636E8702B}"/>
              </a:ext>
            </a:extLst>
          </p:cNvPr>
          <p:cNvSpPr txBox="1"/>
          <p:nvPr/>
        </p:nvSpPr>
        <p:spPr>
          <a:xfrm>
            <a:off x="4510267" y="457201"/>
            <a:ext cx="252713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HBEC EV CD81 WB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2BDD689-0602-BD3B-9D0A-11B3F91DEC7E}"/>
              </a:ext>
            </a:extLst>
          </p:cNvPr>
          <p:cNvSpPr txBox="1"/>
          <p:nvPr/>
        </p:nvSpPr>
        <p:spPr>
          <a:xfrm>
            <a:off x="2415632" y="4468357"/>
            <a:ext cx="6977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D8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C49F16B-5D3C-F664-8F1A-756F80E54E6C}"/>
              </a:ext>
            </a:extLst>
          </p:cNvPr>
          <p:cNvSpPr txBox="1"/>
          <p:nvPr/>
        </p:nvSpPr>
        <p:spPr>
          <a:xfrm>
            <a:off x="9213447" y="4468357"/>
            <a:ext cx="789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20kD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E082610-3852-4F5E-FB87-D408DBA8B692}"/>
              </a:ext>
            </a:extLst>
          </p:cNvPr>
          <p:cNvSpPr txBox="1"/>
          <p:nvPr/>
        </p:nvSpPr>
        <p:spPr>
          <a:xfrm>
            <a:off x="3422830" y="1827217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B040108-CD3B-96DD-EC56-AC9926494C05}"/>
              </a:ext>
            </a:extLst>
          </p:cNvPr>
          <p:cNvSpPr txBox="1"/>
          <p:nvPr/>
        </p:nvSpPr>
        <p:spPr>
          <a:xfrm>
            <a:off x="3810001" y="1824323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2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0A76455-AE65-7886-68F5-2DBD3EC1EEAE}"/>
              </a:ext>
            </a:extLst>
          </p:cNvPr>
          <p:cNvSpPr txBox="1"/>
          <p:nvPr/>
        </p:nvSpPr>
        <p:spPr>
          <a:xfrm>
            <a:off x="6574036" y="1769217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05E1D20-B1F3-C079-65DA-1C11C1D660D8}"/>
              </a:ext>
            </a:extLst>
          </p:cNvPr>
          <p:cNvSpPr txBox="1"/>
          <p:nvPr/>
        </p:nvSpPr>
        <p:spPr>
          <a:xfrm>
            <a:off x="6968924" y="1773547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A696543-BF13-965D-7B68-B19B7D706CF7}"/>
              </a:ext>
            </a:extLst>
          </p:cNvPr>
          <p:cNvSpPr txBox="1"/>
          <p:nvPr/>
        </p:nvSpPr>
        <p:spPr>
          <a:xfrm>
            <a:off x="5589713" y="1762575"/>
            <a:ext cx="635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WCL</a:t>
            </a: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59BFE271-107A-1301-C3E4-A06259404963}"/>
              </a:ext>
            </a:extLst>
          </p:cNvPr>
          <p:cNvCxnSpPr/>
          <p:nvPr/>
        </p:nvCxnSpPr>
        <p:spPr>
          <a:xfrm>
            <a:off x="3422830" y="1856680"/>
            <a:ext cx="83665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EA64B275-57E4-5737-A3DE-D109B40DB54B}"/>
              </a:ext>
            </a:extLst>
          </p:cNvPr>
          <p:cNvSpPr txBox="1"/>
          <p:nvPr/>
        </p:nvSpPr>
        <p:spPr>
          <a:xfrm>
            <a:off x="3422830" y="1466638"/>
            <a:ext cx="10226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ontrol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56E3AF36-6697-7F45-175B-5964D596AD82}"/>
              </a:ext>
            </a:extLst>
          </p:cNvPr>
          <p:cNvCxnSpPr/>
          <p:nvPr/>
        </p:nvCxnSpPr>
        <p:spPr>
          <a:xfrm>
            <a:off x="6526098" y="1787762"/>
            <a:ext cx="83665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64F649BE-E81C-ED1E-D592-852E00132093}"/>
              </a:ext>
            </a:extLst>
          </p:cNvPr>
          <p:cNvSpPr txBox="1"/>
          <p:nvPr/>
        </p:nvSpPr>
        <p:spPr>
          <a:xfrm>
            <a:off x="6526098" y="1397720"/>
            <a:ext cx="10226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A01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CA42DD81-407A-8D1E-91CF-50835732055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20000"/>
                    </a14:imgEffect>
                  </a14:imgLayer>
                </a14:imgProps>
              </a:ext>
            </a:extLst>
          </a:blip>
          <a:srcRect l="4987" t="52004" r="1322" b="324"/>
          <a:stretch/>
        </p:blipFill>
        <p:spPr>
          <a:xfrm>
            <a:off x="3113390" y="2115729"/>
            <a:ext cx="6100057" cy="32756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99087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9</TotalTime>
  <Words>161</Words>
  <Application>Microsoft Macintosh PowerPoint</Application>
  <PresentationFormat>Widescreen</PresentationFormat>
  <Paragraphs>120</Paragraphs>
  <Slides>1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6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HBEC EV WB</dc:title>
  <dc:creator>Rajalakshmy Ayilam Ramachandran</dc:creator>
  <cp:lastModifiedBy>Danielle Robertson</cp:lastModifiedBy>
  <cp:revision>3</cp:revision>
  <dcterms:created xsi:type="dcterms:W3CDTF">2024-01-25T04:03:01Z</dcterms:created>
  <dcterms:modified xsi:type="dcterms:W3CDTF">2024-01-30T19:21:09Z</dcterms:modified>
</cp:coreProperties>
</file>